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emf" ContentType="image/x-em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</p:sldIdLst>
  <p:sldSz cx="9144000" cy="6858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504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10"/>
    <p:restoredTop sz="94682"/>
  </p:normalViewPr>
  <p:slideViewPr>
    <p:cSldViewPr showGuides="1">
      <p:cViewPr varScale="1">
        <p:scale>
          <a:sx n="119" d="100"/>
          <a:sy n="119" d="100"/>
        </p:scale>
        <p:origin x="1440" y="184"/>
      </p:cViewPr>
      <p:guideLst>
        <p:guide orient="horz" pos="3504"/>
        <p:guide pos="2880"/>
      </p:guideLst>
    </p:cSldViewPr>
  </p:slideViewPr>
  <p:notesTextViewPr>
    <p:cViewPr>
      <p:scale>
        <a:sx n="100" d="100"/>
        <a:sy n="100" d="100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" Type="http://schemas.openxmlformats.org/officeDocument/2006/relationships/viewProps" Target="viewProps.xml"/><Relationship Id="rId5" Type="http://schemas.openxmlformats.org/officeDocument/2006/relationships/theme" Target="theme/theme1.xml"/><Relationship Id="rId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F6677-1D42-4A7B-A625-43EA41390959}" type="datetimeFigureOut">
              <a:rPr lang="en-US" smtClean="0"/>
              <a:t>12/2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55BA1-1389-4508-BB63-0A0774D3665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F6677-1D42-4A7B-A625-43EA41390959}" type="datetimeFigureOut">
              <a:rPr lang="en-US" smtClean="0"/>
              <a:t>12/2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55BA1-1389-4508-BB63-0A0774D3665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F6677-1D42-4A7B-A625-43EA41390959}" type="datetimeFigureOut">
              <a:rPr lang="en-US" smtClean="0"/>
              <a:t>12/2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55BA1-1389-4508-BB63-0A0774D3665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F6677-1D42-4A7B-A625-43EA41390959}" type="datetimeFigureOut">
              <a:rPr lang="en-US" smtClean="0"/>
              <a:t>12/2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55BA1-1389-4508-BB63-0A0774D3665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F6677-1D42-4A7B-A625-43EA41390959}" type="datetimeFigureOut">
              <a:rPr lang="en-US" smtClean="0"/>
              <a:t>12/2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55BA1-1389-4508-BB63-0A0774D3665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F6677-1D42-4A7B-A625-43EA41390959}" type="datetimeFigureOut">
              <a:rPr lang="en-US" smtClean="0"/>
              <a:t>12/2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55BA1-1389-4508-BB63-0A0774D3665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F6677-1D42-4A7B-A625-43EA41390959}" type="datetimeFigureOut">
              <a:rPr lang="en-US" smtClean="0"/>
              <a:t>12/22/15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55BA1-1389-4508-BB63-0A0774D3665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F6677-1D42-4A7B-A625-43EA41390959}" type="datetimeFigureOut">
              <a:rPr lang="en-US" smtClean="0"/>
              <a:t>12/22/15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55BA1-1389-4508-BB63-0A0774D3665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F6677-1D42-4A7B-A625-43EA41390959}" type="datetimeFigureOut">
              <a:rPr lang="en-US" smtClean="0"/>
              <a:t>12/22/15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55BA1-1389-4508-BB63-0A0774D3665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F6677-1D42-4A7B-A625-43EA41390959}" type="datetimeFigureOut">
              <a:rPr lang="en-US" smtClean="0"/>
              <a:t>12/2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55BA1-1389-4508-BB63-0A0774D3665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30F6677-1D42-4A7B-A625-43EA41390959}" type="datetimeFigureOut">
              <a:rPr lang="en-US" smtClean="0"/>
              <a:t>12/22/15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DF755BA1-1389-4508-BB63-0A0774D36652}" type="slidenum">
              <a:rPr lang="en-US" smtClean="0"/>
              <a:t>‹#›</a:t>
            </a:fld>
            <a:endParaRPr lang="en-US"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30F6677-1D42-4A7B-A625-43EA41390959}" type="datetimeFigureOut">
              <a:rPr lang="en-US" smtClean="0"/>
              <a:t>12/22/15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DF755BA1-1389-4508-BB63-0A0774D36652}" type="slidenum">
              <a:rPr lang="en-US" smtClean="0"/>
              <a:t>‹#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Relationship Id="rId2" Type="http://schemas.openxmlformats.org/officeDocument/2006/relationships/image" Target="../media/image1.emf"/><Relationship Id="rId3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86154" y="645390"/>
            <a:ext cx="7419646" cy="4460009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173183" y="6130636"/>
            <a:ext cx="897081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smtClean="0"/>
              <a:t>Suppl. Figure 1.  Quantification of tamoxifen on MALDI target plate using normalization of signal intensity on a matrix peak (</a:t>
            </a:r>
            <a:r>
              <a:rPr lang="en-US" i="1" dirty="0" smtClean="0"/>
              <a:t>m/z</a:t>
            </a:r>
            <a:r>
              <a:rPr lang="en-US" dirty="0" smtClean="0"/>
              <a:t> 379.092)</a:t>
            </a:r>
            <a:endParaRPr lang="en-US" dirty="0"/>
          </a:p>
        </p:txBody>
      </p:sp>
      <p:pic>
        <p:nvPicPr>
          <p:cNvPr id="4" name="Picture 3"/>
          <p:cNvPicPr>
            <a:picLocks noChangeAspect="1"/>
          </p:cNvPicPr>
          <p:nvPr/>
        </p:nvPicPr>
        <p:blipFill rotWithShape="1">
          <a:blip r:embed="rId3"/>
          <a:srcRect l="7891" t="2043" r="2015" b="3198"/>
          <a:stretch/>
        </p:blipFill>
        <p:spPr>
          <a:xfrm>
            <a:off x="1981200" y="732123"/>
            <a:ext cx="2819400" cy="178247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241304038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55</TotalTime>
  <Words>25</Words>
  <Application>Microsoft Macintosh PowerPoint</Application>
  <PresentationFormat>On-screen Show (4:3)</PresentationFormat>
  <Paragraphs>1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 Theme</vt:lpstr>
      <vt:lpstr>PowerPoint Presentation</vt:lpstr>
    </vt:vector>
  </TitlesOfParts>
  <Company>LUnd University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MALDI_Orbitrap</dc:creator>
  <cp:lastModifiedBy>Akos Vegvari</cp:lastModifiedBy>
  <cp:revision>7</cp:revision>
  <dcterms:created xsi:type="dcterms:W3CDTF">2015-09-11T13:11:12Z</dcterms:created>
  <dcterms:modified xsi:type="dcterms:W3CDTF">2015-12-22T23:59:42Z</dcterms:modified>
</cp:coreProperties>
</file>